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0066FF"/>
    <a:srgbClr val="502C00"/>
    <a:srgbClr val="4169E1"/>
    <a:srgbClr val="3A7E71"/>
    <a:srgbClr val="9400D3"/>
    <a:srgbClr val="008B00"/>
    <a:srgbClr val="B8860B"/>
    <a:srgbClr val="8B008B"/>
    <a:srgbClr val="6495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338" autoAdjust="0"/>
    <p:restoredTop sz="94660"/>
  </p:normalViewPr>
  <p:slideViewPr>
    <p:cSldViewPr snapToGrid="0">
      <p:cViewPr varScale="1">
        <p:scale>
          <a:sx n="85" d="100"/>
          <a:sy n="85" d="100"/>
        </p:scale>
        <p:origin x="7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7" d="100"/>
        <a:sy n="137" d="100"/>
      </p:scale>
      <p:origin x="0" y="-99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5EEEA5-FA34-4AC8-A800-7356720F426C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D2071C-2D6A-4719-B441-859B23D7614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5029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0106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1760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7221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2703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7773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1064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219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4672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1862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4220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148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D4321-222A-4E8C-B30C-E6FE2C5B1298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8CA60-56E0-4B08-8D66-4F6F0260AE1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5058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6">
            <a:extLst>
              <a:ext uri="{FF2B5EF4-FFF2-40B4-BE49-F238E27FC236}">
                <a16:creationId xmlns:a16="http://schemas.microsoft.com/office/drawing/2014/main" id="{D8613361-1B97-4474-A91E-8B0E2A2672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9553" y="587512"/>
            <a:ext cx="9108142" cy="5682976"/>
          </a:xfrm>
          <a:prstGeom prst="rect">
            <a:avLst/>
          </a:prstGeom>
          <a:noFill/>
          <a:ln w="15875" cap="rnd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23D10F10-6B4D-4392-9979-26C5B3EB30B7}"/>
              </a:ext>
            </a:extLst>
          </p:cNvPr>
          <p:cNvGrpSpPr/>
          <p:nvPr/>
        </p:nvGrpSpPr>
        <p:grpSpPr>
          <a:xfrm>
            <a:off x="713275" y="655795"/>
            <a:ext cx="10433145" cy="5582708"/>
            <a:chOff x="1500354" y="722504"/>
            <a:chExt cx="8591889" cy="4702382"/>
          </a:xfrm>
        </p:grpSpPr>
        <p:sp>
          <p:nvSpPr>
            <p:cNvPr id="10" name="Freeform 7">
              <a:extLst>
                <a:ext uri="{FF2B5EF4-FFF2-40B4-BE49-F238E27FC236}">
                  <a16:creationId xmlns:a16="http://schemas.microsoft.com/office/drawing/2014/main" id="{5D702FE4-9BBB-4441-A1BC-5E4F5AD10F3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50145" y="2013484"/>
              <a:ext cx="7842098" cy="0"/>
            </a:xfrm>
            <a:custGeom>
              <a:avLst/>
              <a:gdLst>
                <a:gd name="T0" fmla="*/ 4 w 378"/>
                <a:gd name="T1" fmla="*/ 12 w 378"/>
                <a:gd name="T2" fmla="*/ 20 w 378"/>
                <a:gd name="T3" fmla="*/ 28 w 378"/>
                <a:gd name="T4" fmla="*/ 36 w 378"/>
                <a:gd name="T5" fmla="*/ 44 w 378"/>
                <a:gd name="T6" fmla="*/ 52 w 378"/>
                <a:gd name="T7" fmla="*/ 60 w 378"/>
                <a:gd name="T8" fmla="*/ 68 w 378"/>
                <a:gd name="T9" fmla="*/ 76 w 378"/>
                <a:gd name="T10" fmla="*/ 84 w 378"/>
                <a:gd name="T11" fmla="*/ 92 w 378"/>
                <a:gd name="T12" fmla="*/ 100 w 378"/>
                <a:gd name="T13" fmla="*/ 108 w 378"/>
                <a:gd name="T14" fmla="*/ 116 w 378"/>
                <a:gd name="T15" fmla="*/ 124 w 378"/>
                <a:gd name="T16" fmla="*/ 132 w 378"/>
                <a:gd name="T17" fmla="*/ 140 w 378"/>
                <a:gd name="T18" fmla="*/ 148 w 378"/>
                <a:gd name="T19" fmla="*/ 156 w 378"/>
                <a:gd name="T20" fmla="*/ 164 w 378"/>
                <a:gd name="T21" fmla="*/ 172 w 378"/>
                <a:gd name="T22" fmla="*/ 180 w 378"/>
                <a:gd name="T23" fmla="*/ 188 w 378"/>
                <a:gd name="T24" fmla="*/ 196 w 378"/>
                <a:gd name="T25" fmla="*/ 204 w 378"/>
                <a:gd name="T26" fmla="*/ 212 w 378"/>
                <a:gd name="T27" fmla="*/ 220 w 378"/>
                <a:gd name="T28" fmla="*/ 228 w 378"/>
                <a:gd name="T29" fmla="*/ 236 w 378"/>
                <a:gd name="T30" fmla="*/ 244 w 378"/>
                <a:gd name="T31" fmla="*/ 252 w 378"/>
                <a:gd name="T32" fmla="*/ 260 w 378"/>
                <a:gd name="T33" fmla="*/ 268 w 378"/>
                <a:gd name="T34" fmla="*/ 276 w 378"/>
                <a:gd name="T35" fmla="*/ 284 w 378"/>
                <a:gd name="T36" fmla="*/ 292 w 378"/>
                <a:gd name="T37" fmla="*/ 300 w 378"/>
                <a:gd name="T38" fmla="*/ 308 w 378"/>
                <a:gd name="T39" fmla="*/ 316 w 378"/>
                <a:gd name="T40" fmla="*/ 324 w 378"/>
                <a:gd name="T41" fmla="*/ 332 w 378"/>
                <a:gd name="T42" fmla="*/ 340 w 378"/>
                <a:gd name="T43" fmla="*/ 348 w 378"/>
                <a:gd name="T44" fmla="*/ 356 w 378"/>
                <a:gd name="T45" fmla="*/ 364 w 378"/>
                <a:gd name="T46" fmla="*/ 372 w 37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</a:cxnLst>
              <a:rect l="0" t="0" r="r" b="b"/>
              <a:pathLst>
                <a:path w="378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  <a:moveTo>
                    <a:pt x="172" y="0"/>
                  </a:moveTo>
                  <a:lnTo>
                    <a:pt x="176" y="0"/>
                  </a:lnTo>
                  <a:moveTo>
                    <a:pt x="180" y="0"/>
                  </a:moveTo>
                  <a:lnTo>
                    <a:pt x="184" y="0"/>
                  </a:lnTo>
                  <a:moveTo>
                    <a:pt x="188" y="0"/>
                  </a:moveTo>
                  <a:lnTo>
                    <a:pt x="192" y="0"/>
                  </a:lnTo>
                  <a:moveTo>
                    <a:pt x="196" y="0"/>
                  </a:moveTo>
                  <a:lnTo>
                    <a:pt x="200" y="0"/>
                  </a:lnTo>
                  <a:moveTo>
                    <a:pt x="204" y="0"/>
                  </a:moveTo>
                  <a:lnTo>
                    <a:pt x="208" y="0"/>
                  </a:lnTo>
                  <a:moveTo>
                    <a:pt x="212" y="0"/>
                  </a:moveTo>
                  <a:lnTo>
                    <a:pt x="216" y="0"/>
                  </a:lnTo>
                  <a:moveTo>
                    <a:pt x="220" y="0"/>
                  </a:moveTo>
                  <a:lnTo>
                    <a:pt x="224" y="0"/>
                  </a:lnTo>
                  <a:moveTo>
                    <a:pt x="228" y="0"/>
                  </a:moveTo>
                  <a:lnTo>
                    <a:pt x="232" y="0"/>
                  </a:lnTo>
                  <a:moveTo>
                    <a:pt x="236" y="0"/>
                  </a:moveTo>
                  <a:lnTo>
                    <a:pt x="240" y="0"/>
                  </a:lnTo>
                  <a:moveTo>
                    <a:pt x="244" y="0"/>
                  </a:moveTo>
                  <a:lnTo>
                    <a:pt x="248" y="0"/>
                  </a:lnTo>
                  <a:moveTo>
                    <a:pt x="252" y="0"/>
                  </a:moveTo>
                  <a:lnTo>
                    <a:pt x="256" y="0"/>
                  </a:lnTo>
                  <a:moveTo>
                    <a:pt x="260" y="0"/>
                  </a:moveTo>
                  <a:lnTo>
                    <a:pt x="264" y="0"/>
                  </a:lnTo>
                  <a:moveTo>
                    <a:pt x="268" y="0"/>
                  </a:moveTo>
                  <a:lnTo>
                    <a:pt x="272" y="0"/>
                  </a:lnTo>
                  <a:moveTo>
                    <a:pt x="276" y="0"/>
                  </a:moveTo>
                  <a:lnTo>
                    <a:pt x="280" y="0"/>
                  </a:lnTo>
                  <a:moveTo>
                    <a:pt x="284" y="0"/>
                  </a:moveTo>
                  <a:lnTo>
                    <a:pt x="288" y="0"/>
                  </a:lnTo>
                  <a:moveTo>
                    <a:pt x="292" y="0"/>
                  </a:moveTo>
                  <a:lnTo>
                    <a:pt x="296" y="0"/>
                  </a:lnTo>
                  <a:moveTo>
                    <a:pt x="300" y="0"/>
                  </a:moveTo>
                  <a:lnTo>
                    <a:pt x="304" y="0"/>
                  </a:lnTo>
                  <a:moveTo>
                    <a:pt x="308" y="0"/>
                  </a:moveTo>
                  <a:lnTo>
                    <a:pt x="312" y="0"/>
                  </a:lnTo>
                  <a:moveTo>
                    <a:pt x="316" y="0"/>
                  </a:moveTo>
                  <a:lnTo>
                    <a:pt x="320" y="0"/>
                  </a:lnTo>
                  <a:moveTo>
                    <a:pt x="324" y="0"/>
                  </a:moveTo>
                  <a:lnTo>
                    <a:pt x="328" y="0"/>
                  </a:lnTo>
                  <a:moveTo>
                    <a:pt x="332" y="0"/>
                  </a:moveTo>
                  <a:lnTo>
                    <a:pt x="336" y="0"/>
                  </a:lnTo>
                  <a:moveTo>
                    <a:pt x="340" y="0"/>
                  </a:moveTo>
                  <a:lnTo>
                    <a:pt x="344" y="0"/>
                  </a:lnTo>
                  <a:moveTo>
                    <a:pt x="348" y="0"/>
                  </a:moveTo>
                  <a:lnTo>
                    <a:pt x="352" y="0"/>
                  </a:lnTo>
                  <a:moveTo>
                    <a:pt x="356" y="0"/>
                  </a:moveTo>
                  <a:lnTo>
                    <a:pt x="360" y="0"/>
                  </a:lnTo>
                  <a:moveTo>
                    <a:pt x="364" y="0"/>
                  </a:moveTo>
                  <a:lnTo>
                    <a:pt x="368" y="0"/>
                  </a:lnTo>
                  <a:moveTo>
                    <a:pt x="372" y="0"/>
                  </a:moveTo>
                  <a:lnTo>
                    <a:pt x="376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solidFill>
                  <a:schemeClr val="bg2">
                    <a:lumMod val="75000"/>
                  </a:schemeClr>
                </a:solidFill>
              </a:endParaRPr>
            </a:p>
          </p:txBody>
        </p:sp>
        <p:sp>
          <p:nvSpPr>
            <p:cNvPr id="11" name="Freeform 8">
              <a:extLst>
                <a:ext uri="{FF2B5EF4-FFF2-40B4-BE49-F238E27FC236}">
                  <a16:creationId xmlns:a16="http://schemas.microsoft.com/office/drawing/2014/main" id="{34EA777E-3322-478E-BFCD-F0D17B3DD3A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75567" y="722504"/>
              <a:ext cx="0" cy="4083985"/>
            </a:xfrm>
            <a:custGeom>
              <a:avLst/>
              <a:gdLst>
                <a:gd name="T0" fmla="*/ 212 h 212"/>
                <a:gd name="T1" fmla="*/ 208 h 212"/>
                <a:gd name="T2" fmla="*/ 204 h 212"/>
                <a:gd name="T3" fmla="*/ 200 h 212"/>
                <a:gd name="T4" fmla="*/ 196 h 212"/>
                <a:gd name="T5" fmla="*/ 192 h 212"/>
                <a:gd name="T6" fmla="*/ 188 h 212"/>
                <a:gd name="T7" fmla="*/ 184 h 212"/>
                <a:gd name="T8" fmla="*/ 180 h 212"/>
                <a:gd name="T9" fmla="*/ 176 h 212"/>
                <a:gd name="T10" fmla="*/ 172 h 212"/>
                <a:gd name="T11" fmla="*/ 168 h 212"/>
                <a:gd name="T12" fmla="*/ 164 h 212"/>
                <a:gd name="T13" fmla="*/ 160 h 212"/>
                <a:gd name="T14" fmla="*/ 156 h 212"/>
                <a:gd name="T15" fmla="*/ 152 h 212"/>
                <a:gd name="T16" fmla="*/ 148 h 212"/>
                <a:gd name="T17" fmla="*/ 144 h 212"/>
                <a:gd name="T18" fmla="*/ 140 h 212"/>
                <a:gd name="T19" fmla="*/ 136 h 212"/>
                <a:gd name="T20" fmla="*/ 132 h 212"/>
                <a:gd name="T21" fmla="*/ 128 h 212"/>
                <a:gd name="T22" fmla="*/ 124 h 212"/>
                <a:gd name="T23" fmla="*/ 120 h 212"/>
                <a:gd name="T24" fmla="*/ 116 h 212"/>
                <a:gd name="T25" fmla="*/ 112 h 212"/>
                <a:gd name="T26" fmla="*/ 108 h 212"/>
                <a:gd name="T27" fmla="*/ 104 h 212"/>
                <a:gd name="T28" fmla="*/ 100 h 212"/>
                <a:gd name="T29" fmla="*/ 96 h 212"/>
                <a:gd name="T30" fmla="*/ 92 h 212"/>
                <a:gd name="T31" fmla="*/ 88 h 212"/>
                <a:gd name="T32" fmla="*/ 84 h 212"/>
                <a:gd name="T33" fmla="*/ 80 h 212"/>
                <a:gd name="T34" fmla="*/ 76 h 212"/>
                <a:gd name="T35" fmla="*/ 72 h 212"/>
                <a:gd name="T36" fmla="*/ 68 h 212"/>
                <a:gd name="T37" fmla="*/ 64 h 212"/>
                <a:gd name="T38" fmla="*/ 60 h 212"/>
                <a:gd name="T39" fmla="*/ 56 h 212"/>
                <a:gd name="T40" fmla="*/ 52 h 212"/>
                <a:gd name="T41" fmla="*/ 48 h 212"/>
                <a:gd name="T42" fmla="*/ 44 h 212"/>
                <a:gd name="T43" fmla="*/ 40 h 212"/>
                <a:gd name="T44" fmla="*/ 36 h 212"/>
                <a:gd name="T45" fmla="*/ 32 h 212"/>
                <a:gd name="T46" fmla="*/ 28 h 212"/>
                <a:gd name="T47" fmla="*/ 24 h 212"/>
                <a:gd name="T48" fmla="*/ 20 h 212"/>
                <a:gd name="T49" fmla="*/ 16 h 212"/>
                <a:gd name="T50" fmla="*/ 12 h 212"/>
                <a:gd name="T51" fmla="*/ 8 h 212"/>
                <a:gd name="T52" fmla="*/ 4 h 2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  <a:cxn ang="0">
                  <a:pos x="0" y="T50"/>
                </a:cxn>
                <a:cxn ang="0">
                  <a:pos x="0" y="T51"/>
                </a:cxn>
                <a:cxn ang="0">
                  <a:pos x="0" y="T52"/>
                </a:cxn>
              </a:cxnLst>
              <a:rect l="0" t="0" r="r" b="b"/>
              <a:pathLst>
                <a:path h="212">
                  <a:moveTo>
                    <a:pt x="0" y="208"/>
                  </a:moveTo>
                  <a:lnTo>
                    <a:pt x="0" y="204"/>
                  </a:lnTo>
                  <a:moveTo>
                    <a:pt x="0" y="200"/>
                  </a:moveTo>
                  <a:lnTo>
                    <a:pt x="0" y="196"/>
                  </a:lnTo>
                  <a:moveTo>
                    <a:pt x="0" y="192"/>
                  </a:moveTo>
                  <a:lnTo>
                    <a:pt x="0" y="188"/>
                  </a:lnTo>
                  <a:moveTo>
                    <a:pt x="0" y="184"/>
                  </a:moveTo>
                  <a:lnTo>
                    <a:pt x="0" y="180"/>
                  </a:lnTo>
                  <a:moveTo>
                    <a:pt x="0" y="176"/>
                  </a:moveTo>
                  <a:lnTo>
                    <a:pt x="0" y="172"/>
                  </a:lnTo>
                  <a:moveTo>
                    <a:pt x="0" y="168"/>
                  </a:moveTo>
                  <a:lnTo>
                    <a:pt x="0" y="164"/>
                  </a:lnTo>
                  <a:moveTo>
                    <a:pt x="0" y="160"/>
                  </a:moveTo>
                  <a:lnTo>
                    <a:pt x="0" y="156"/>
                  </a:lnTo>
                  <a:moveTo>
                    <a:pt x="0" y="152"/>
                  </a:moveTo>
                  <a:lnTo>
                    <a:pt x="0" y="148"/>
                  </a:lnTo>
                  <a:moveTo>
                    <a:pt x="0" y="144"/>
                  </a:moveTo>
                  <a:lnTo>
                    <a:pt x="0" y="140"/>
                  </a:lnTo>
                  <a:moveTo>
                    <a:pt x="0" y="136"/>
                  </a:moveTo>
                  <a:lnTo>
                    <a:pt x="0" y="132"/>
                  </a:lnTo>
                  <a:moveTo>
                    <a:pt x="0" y="128"/>
                  </a:moveTo>
                  <a:lnTo>
                    <a:pt x="0" y="124"/>
                  </a:lnTo>
                  <a:moveTo>
                    <a:pt x="0" y="120"/>
                  </a:moveTo>
                  <a:lnTo>
                    <a:pt x="0" y="116"/>
                  </a:lnTo>
                  <a:moveTo>
                    <a:pt x="0" y="112"/>
                  </a:moveTo>
                  <a:lnTo>
                    <a:pt x="0" y="108"/>
                  </a:lnTo>
                  <a:moveTo>
                    <a:pt x="0" y="104"/>
                  </a:moveTo>
                  <a:lnTo>
                    <a:pt x="0" y="100"/>
                  </a:lnTo>
                  <a:moveTo>
                    <a:pt x="0" y="96"/>
                  </a:moveTo>
                  <a:lnTo>
                    <a:pt x="0" y="92"/>
                  </a:lnTo>
                  <a:moveTo>
                    <a:pt x="0" y="88"/>
                  </a:moveTo>
                  <a:lnTo>
                    <a:pt x="0" y="84"/>
                  </a:lnTo>
                  <a:moveTo>
                    <a:pt x="0" y="80"/>
                  </a:moveTo>
                  <a:lnTo>
                    <a:pt x="0" y="76"/>
                  </a:lnTo>
                  <a:moveTo>
                    <a:pt x="0" y="72"/>
                  </a:moveTo>
                  <a:lnTo>
                    <a:pt x="0" y="68"/>
                  </a:lnTo>
                  <a:moveTo>
                    <a:pt x="0" y="64"/>
                  </a:moveTo>
                  <a:lnTo>
                    <a:pt x="0" y="60"/>
                  </a:lnTo>
                  <a:moveTo>
                    <a:pt x="0" y="56"/>
                  </a:moveTo>
                  <a:lnTo>
                    <a:pt x="0" y="52"/>
                  </a:lnTo>
                  <a:moveTo>
                    <a:pt x="0" y="48"/>
                  </a:moveTo>
                  <a:lnTo>
                    <a:pt x="0" y="44"/>
                  </a:lnTo>
                  <a:moveTo>
                    <a:pt x="0" y="40"/>
                  </a:moveTo>
                  <a:lnTo>
                    <a:pt x="0" y="36"/>
                  </a:lnTo>
                  <a:moveTo>
                    <a:pt x="0" y="32"/>
                  </a:moveTo>
                  <a:lnTo>
                    <a:pt x="0" y="28"/>
                  </a:lnTo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solidFill>
                  <a:schemeClr val="bg2">
                    <a:lumMod val="75000"/>
                  </a:schemeClr>
                </a:solidFill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A0958B73-6D4D-45BB-93F1-ED55DD35D5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5392" y="1599002"/>
              <a:ext cx="10038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N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220D42E7-781B-4CB9-951C-D56A0EE598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8099" y="1751106"/>
              <a:ext cx="1298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C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FD756E23-5CAA-4320-A050-CCFBB1E244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43214" y="195454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Al</a:t>
              </a:r>
              <a:endParaRPr kumimoji="0" lang="en-US" altLang="en-US" sz="14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2883C394-1D88-421D-B4FF-332C1ABF20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537" y="1329018"/>
              <a:ext cx="2292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Ca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2BA2690E-4111-45ED-B84E-499022B063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1884" y="4593544"/>
              <a:ext cx="23884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Cu</a:t>
              </a:r>
              <a:endParaRPr kumimoji="0" lang="en-US" altLang="en-US" sz="14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06166346-E6E4-4FD9-83F5-EB74C7F51C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88559" y="2186503"/>
              <a:ext cx="2083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Fe</a:t>
              </a:r>
              <a:endParaRPr kumimoji="0" lang="en-US" altLang="en-US" sz="14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66E5C592-8AAB-4D92-8231-8337B713A9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52619" y="1483023"/>
              <a:ext cx="1298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K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35E78ED0-A820-4854-94EF-12213F6938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7306" y="1230150"/>
              <a:ext cx="2580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Mg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C28750C7-023C-418A-A745-769F00E631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6432" y="2513526"/>
              <a:ext cx="2580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Mn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029EFC56-51E4-4D39-9D7E-DF95EF59C7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3554" y="3688527"/>
              <a:ext cx="2292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Na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01B966C8-1FD8-452D-9F1C-E6803F5D3C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4315" y="1549568"/>
              <a:ext cx="12022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endParaRPr kumimoji="0" lang="en-US" altLang="en-US" sz="14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3A840F67-9315-46C0-A2F1-B3FAE814D2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127" y="1984965"/>
              <a:ext cx="21800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Zn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38479BA2-3539-428E-9AC6-8E573E3FCB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2022" y="2937515"/>
              <a:ext cx="138980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 dirty="0">
                  <a:ln>
                    <a:noFill/>
                  </a:ln>
                  <a:solidFill>
                    <a:srgbClr val="6495ED"/>
                  </a:solidFill>
                  <a:effectLst/>
                  <a:latin typeface="Arial" panose="020B0604020202020204" pitchFamily="34" charset="0"/>
                </a:rPr>
                <a:t>spruce needles</a:t>
              </a:r>
              <a:endParaRPr kumimoji="0" lang="en-US" altLang="en-US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7474CA21-A2D8-4F4C-8DC1-0C463AD577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68763" y="2629505"/>
              <a:ext cx="138980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>
                  <a:ln>
                    <a:noFill/>
                  </a:ln>
                  <a:solidFill>
                    <a:srgbClr val="6495ED"/>
                  </a:solidFill>
                  <a:effectLst/>
                  <a:latin typeface="Arial" panose="020B0604020202020204" pitchFamily="34" charset="0"/>
                </a:rPr>
                <a:t>spruce needles</a:t>
              </a:r>
              <a:endParaRPr kumimoji="0" lang="en-US" altLang="en-US" sz="16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C9B62248-8C51-4919-9554-0C6C34ED22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4701" y="1703574"/>
              <a:ext cx="138980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 dirty="0">
                  <a:ln>
                    <a:noFill/>
                  </a:ln>
                  <a:solidFill>
                    <a:srgbClr val="6495ED"/>
                  </a:solidFill>
                  <a:effectLst/>
                  <a:latin typeface="Arial" panose="020B0604020202020204" pitchFamily="34" charset="0"/>
                </a:rPr>
                <a:t>spruce needles</a:t>
              </a:r>
              <a:endParaRPr kumimoji="0" lang="en-US" altLang="en-US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9F29B406-A1E9-4093-BA75-6CF4C35A30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6882" y="1587594"/>
              <a:ext cx="138980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 dirty="0">
                  <a:ln>
                    <a:noFill/>
                  </a:ln>
                  <a:solidFill>
                    <a:srgbClr val="6495ED"/>
                  </a:solidFill>
                  <a:effectLst/>
                  <a:latin typeface="Arial" panose="020B0604020202020204" pitchFamily="34" charset="0"/>
                </a:rPr>
                <a:t>spruce needles</a:t>
              </a:r>
              <a:endParaRPr kumimoji="0" lang="en-US" altLang="en-US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FC394194-7946-4F13-ADAB-C17D8BD8AF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247" y="3078491"/>
              <a:ext cx="100348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 dirty="0">
                  <a:ln>
                    <a:noFill/>
                  </a:ln>
                  <a:solidFill>
                    <a:srgbClr val="FF9900"/>
                  </a:solidFill>
                  <a:effectLst/>
                  <a:latin typeface="Arial" panose="020B0604020202020204" pitchFamily="34" charset="0"/>
                </a:rPr>
                <a:t>beech litter</a:t>
              </a: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0AFB922F-5074-4AEE-A628-4C2A0CCD23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6087" y="1792934"/>
              <a:ext cx="100348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 dirty="0">
                  <a:ln>
                    <a:noFill/>
                  </a:ln>
                  <a:solidFill>
                    <a:srgbClr val="FF9900"/>
                  </a:solidFill>
                  <a:effectLst/>
                  <a:latin typeface="Arial" panose="020B0604020202020204" pitchFamily="34" charset="0"/>
                </a:rPr>
                <a:t>beech litter</a:t>
              </a: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E4AB22EE-4C6E-4D3B-97CC-DAD602B41C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34914" y="2011583"/>
              <a:ext cx="100348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 dirty="0">
                  <a:ln>
                    <a:noFill/>
                  </a:ln>
                  <a:solidFill>
                    <a:srgbClr val="FF9900"/>
                  </a:solidFill>
                  <a:effectLst/>
                  <a:latin typeface="Arial" panose="020B0604020202020204" pitchFamily="34" charset="0"/>
                </a:rPr>
                <a:t>beech litter</a:t>
              </a: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62F92E51-AF28-4786-BF3E-585C300665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8413" y="990586"/>
              <a:ext cx="100348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i="0" u="none" strike="noStrike" cap="none" normalizeH="0" baseline="0" dirty="0">
                  <a:ln>
                    <a:noFill/>
                  </a:ln>
                  <a:solidFill>
                    <a:srgbClr val="FF9900"/>
                  </a:solidFill>
                  <a:effectLst/>
                  <a:latin typeface="Arial" panose="020B0604020202020204" pitchFamily="34" charset="0"/>
                </a:rPr>
                <a:t>beech litter</a:t>
              </a: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C191D8BC-C89C-4C81-B53A-1B1E23F5E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6152" y="722504"/>
              <a:ext cx="7926091" cy="4161939"/>
            </a:xfrm>
            <a:prstGeom prst="rect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" name="Line 30">
              <a:extLst>
                <a:ext uri="{FF2B5EF4-FFF2-40B4-BE49-F238E27FC236}">
                  <a16:creationId xmlns:a16="http://schemas.microsoft.com/office/drawing/2014/main" id="{5113FC28-216E-44E0-AAC3-DE17490801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66152" y="722504"/>
              <a:ext cx="0" cy="4161939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solidFill>
                  <a:schemeClr val="bg2">
                    <a:lumMod val="75000"/>
                  </a:schemeClr>
                </a:solidFill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F73C51BA-822E-4D1C-BFC9-052DDF935A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3220" y="3914856"/>
              <a:ext cx="24205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50000"/>
                      <a:lumOff val="50000"/>
                    </a:schemeClr>
                  </a:solidFill>
                  <a:effectLst/>
                  <a:latin typeface="Arial" panose="020B0604020202020204" pitchFamily="34" charset="0"/>
                </a:rPr>
                <a:t>-0.4</a:t>
              </a: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F479AC83-4322-4AD1-970F-414B84E16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3220" y="2912872"/>
              <a:ext cx="24205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50000"/>
                      <a:lumOff val="50000"/>
                    </a:schemeClr>
                  </a:solidFill>
                  <a:effectLst/>
                  <a:latin typeface="Arial" panose="020B0604020202020204" pitchFamily="34" charset="0"/>
                </a:rPr>
                <a:t>-0.2</a:t>
              </a: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8C22484D-D627-486D-A4FE-0B8D2AF590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163" y="192990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>
                  <a:ln>
                    <a:noFill/>
                  </a:ln>
                  <a:solidFill>
                    <a:schemeClr val="tx1">
                      <a:lumMod val="50000"/>
                      <a:lumOff val="50000"/>
                    </a:schemeClr>
                  </a:solidFill>
                  <a:effectLst/>
                  <a:latin typeface="Arial" panose="020B0604020202020204" pitchFamily="34" charset="0"/>
                </a:rPr>
                <a:t>0.0</a:t>
              </a: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3C9AE3FB-FAD9-4CAE-BD20-50D14823D4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163" y="92791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50000"/>
                      <a:lumOff val="50000"/>
                    </a:schemeClr>
                  </a:solidFill>
                  <a:effectLst/>
                  <a:latin typeface="Arial" panose="020B0604020202020204" pitchFamily="34" charset="0"/>
                </a:rPr>
                <a:t>0.2</a:t>
              </a:r>
            </a:p>
          </p:txBody>
        </p:sp>
        <p:sp>
          <p:nvSpPr>
            <p:cNvPr id="38" name="Line 35">
              <a:extLst>
                <a:ext uri="{FF2B5EF4-FFF2-40B4-BE49-F238E27FC236}">
                  <a16:creationId xmlns:a16="http://schemas.microsoft.com/office/drawing/2014/main" id="{F7C51C25-996C-40A3-8D8D-8882771D09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4208" y="3998439"/>
              <a:ext cx="81945" cy="0"/>
            </a:xfrm>
            <a:prstGeom prst="line">
              <a:avLst/>
            </a:prstGeom>
            <a:noFill/>
            <a:ln w="15875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solidFill>
                  <a:schemeClr val="bg2">
                    <a:lumMod val="75000"/>
                  </a:schemeClr>
                </a:solidFill>
              </a:endParaRPr>
            </a:p>
          </p:txBody>
        </p:sp>
        <p:sp>
          <p:nvSpPr>
            <p:cNvPr id="39" name="Line 36">
              <a:extLst>
                <a:ext uri="{FF2B5EF4-FFF2-40B4-BE49-F238E27FC236}">
                  <a16:creationId xmlns:a16="http://schemas.microsoft.com/office/drawing/2014/main" id="{C09D3BD2-2284-47F6-89A6-99F9125A64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4208" y="3015468"/>
              <a:ext cx="81945" cy="0"/>
            </a:xfrm>
            <a:prstGeom prst="line">
              <a:avLst/>
            </a:prstGeom>
            <a:noFill/>
            <a:ln w="15875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solidFill>
                  <a:schemeClr val="bg2">
                    <a:lumMod val="75000"/>
                  </a:schemeClr>
                </a:solidFill>
              </a:endParaRPr>
            </a:p>
          </p:txBody>
        </p:sp>
        <p:sp>
          <p:nvSpPr>
            <p:cNvPr id="40" name="Line 37">
              <a:extLst>
                <a:ext uri="{FF2B5EF4-FFF2-40B4-BE49-F238E27FC236}">
                  <a16:creationId xmlns:a16="http://schemas.microsoft.com/office/drawing/2014/main" id="{A348BC22-4D24-4763-9908-FC3D4CFD2C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4208" y="2013484"/>
              <a:ext cx="81945" cy="0"/>
            </a:xfrm>
            <a:prstGeom prst="line">
              <a:avLst/>
            </a:prstGeom>
            <a:noFill/>
            <a:ln w="15875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solidFill>
                  <a:schemeClr val="bg2">
                    <a:lumMod val="75000"/>
                  </a:schemeClr>
                </a:solidFill>
              </a:endParaRPr>
            </a:p>
          </p:txBody>
        </p:sp>
        <p:sp>
          <p:nvSpPr>
            <p:cNvPr id="41" name="Line 38">
              <a:extLst>
                <a:ext uri="{FF2B5EF4-FFF2-40B4-BE49-F238E27FC236}">
                  <a16:creationId xmlns:a16="http://schemas.microsoft.com/office/drawing/2014/main" id="{6C7545C9-D9D2-491B-AA7D-387A99F9EC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4208" y="1030514"/>
              <a:ext cx="81945" cy="0"/>
            </a:xfrm>
            <a:prstGeom prst="line">
              <a:avLst/>
            </a:prstGeom>
            <a:noFill/>
            <a:ln w="15875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solidFill>
                  <a:schemeClr val="bg2">
                    <a:lumMod val="75000"/>
                  </a:schemeClr>
                </a:solidFill>
              </a:endParaRPr>
            </a:p>
          </p:txBody>
        </p:sp>
        <p:sp>
          <p:nvSpPr>
            <p:cNvPr id="42" name="Line 39">
              <a:extLst>
                <a:ext uri="{FF2B5EF4-FFF2-40B4-BE49-F238E27FC236}">
                  <a16:creationId xmlns:a16="http://schemas.microsoft.com/office/drawing/2014/main" id="{4ED96190-634B-4996-936F-0F788B9972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6152" y="4884443"/>
              <a:ext cx="7926091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" name="Line 40">
              <a:extLst>
                <a:ext uri="{FF2B5EF4-FFF2-40B4-BE49-F238E27FC236}">
                  <a16:creationId xmlns:a16="http://schemas.microsoft.com/office/drawing/2014/main" id="{23D4AA35-0439-4548-98FD-CC344DE5DD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22993" y="4884443"/>
              <a:ext cx="0" cy="76052"/>
            </a:xfrm>
            <a:prstGeom prst="line">
              <a:avLst/>
            </a:prstGeom>
            <a:noFill/>
            <a:ln w="15875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" name="Line 41">
              <a:extLst>
                <a:ext uri="{FF2B5EF4-FFF2-40B4-BE49-F238E27FC236}">
                  <a16:creationId xmlns:a16="http://schemas.microsoft.com/office/drawing/2014/main" id="{C9293780-A1F6-4C6F-9660-10D81BF59A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75567" y="4884443"/>
              <a:ext cx="0" cy="76052"/>
            </a:xfrm>
            <a:prstGeom prst="line">
              <a:avLst/>
            </a:prstGeom>
            <a:noFill/>
            <a:ln w="15875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" name="Line 42">
              <a:extLst>
                <a:ext uri="{FF2B5EF4-FFF2-40B4-BE49-F238E27FC236}">
                  <a16:creationId xmlns:a16="http://schemas.microsoft.com/office/drawing/2014/main" id="{EAA1D6C5-0666-4443-8D9B-AD5460067B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28142" y="4884443"/>
              <a:ext cx="0" cy="76052"/>
            </a:xfrm>
            <a:prstGeom prst="line">
              <a:avLst/>
            </a:prstGeom>
            <a:noFill/>
            <a:ln w="15875" cap="flat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B5A9982B-3429-46D6-B17B-08159E6DAE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3278" y="4947155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50000"/>
                      <a:lumOff val="50000"/>
                    </a:schemeClr>
                  </a:solidFill>
                  <a:effectLst/>
                  <a:latin typeface="Arial" panose="020B0604020202020204" pitchFamily="34" charset="0"/>
                </a:rPr>
                <a:t>-0.25</a:t>
              </a: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C6FAEF8D-FA81-4B05-A5DA-D808EDF62E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8873" y="4947155"/>
              <a:ext cx="27411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>
                  <a:ln>
                    <a:noFill/>
                  </a:ln>
                  <a:solidFill>
                    <a:schemeClr val="tx1">
                      <a:lumMod val="50000"/>
                      <a:lumOff val="50000"/>
                    </a:schemeClr>
                  </a:solidFill>
                  <a:effectLst/>
                  <a:latin typeface="Arial" panose="020B0604020202020204" pitchFamily="34" charset="0"/>
                </a:rPr>
                <a:t>0.00</a:t>
              </a: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E252B7D4-3E8A-4139-9C95-077A5B8F4D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11447" y="4947155"/>
              <a:ext cx="27411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>
                  <a:ln>
                    <a:noFill/>
                  </a:ln>
                  <a:solidFill>
                    <a:schemeClr val="tx1">
                      <a:lumMod val="50000"/>
                      <a:lumOff val="50000"/>
                    </a:schemeClr>
                  </a:solidFill>
                  <a:effectLst/>
                  <a:latin typeface="Arial" panose="020B0604020202020204" pitchFamily="34" charset="0"/>
                </a:rPr>
                <a:t>0.25</a:t>
              </a: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74A5FBC7-FF0D-4BE2-B95E-9A218B1B21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6976" y="5209442"/>
              <a:ext cx="105772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65000"/>
                      <a:lumOff val="35000"/>
                    </a:schemeClr>
                  </a:solidFill>
                  <a:effectLst/>
                  <a:latin typeface="Arial" panose="020B0604020202020204" pitchFamily="34" charset="0"/>
                </a:rPr>
                <a:t>NMDS Axis 1</a:t>
              </a: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8ACA98DD-CED0-4C96-A63A-45E7B878C81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079213" y="2746738"/>
              <a:ext cx="105772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65000"/>
                      <a:lumOff val="35000"/>
                    </a:schemeClr>
                  </a:solidFill>
                  <a:effectLst/>
                  <a:latin typeface="Arial" panose="020B0604020202020204" pitchFamily="34" charset="0"/>
                </a:rPr>
                <a:t>NMDS Axis 2</a:t>
              </a: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261767DB-BDBF-4BF9-99CB-E5B1F70197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06772" y="5012838"/>
              <a:ext cx="7854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65000"/>
                      <a:lumOff val="35000"/>
                    </a:schemeClr>
                  </a:solidFill>
                  <a:effectLst/>
                  <a:latin typeface="Arial" panose="020B0604020202020204" pitchFamily="34" charset="0"/>
                </a:rPr>
                <a:t>Stress: 0.082 </a:t>
              </a: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11E07FD7-EF38-48BA-9D68-806C707CC0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33033" y="5131014"/>
              <a:ext cx="85921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chemeClr val="tx1">
                      <a:lumMod val="65000"/>
                      <a:lumOff val="35000"/>
                    </a:schemeClr>
                  </a:solidFill>
                  <a:effectLst/>
                  <a:latin typeface="Arial" panose="020B0604020202020204" pitchFamily="34" charset="0"/>
                </a:rPr>
                <a:t>Dimensions: 2</a:t>
              </a:r>
            </a:p>
          </p:txBody>
        </p:sp>
      </p:grpSp>
      <p:sp>
        <p:nvSpPr>
          <p:cNvPr id="54" name="Textfeld 53">
            <a:extLst>
              <a:ext uri="{FF2B5EF4-FFF2-40B4-BE49-F238E27FC236}">
                <a16:creationId xmlns:a16="http://schemas.microsoft.com/office/drawing/2014/main" id="{3BA8E89F-8448-4908-BE6D-2559185A5E43}"/>
              </a:ext>
            </a:extLst>
          </p:cNvPr>
          <p:cNvSpPr txBox="1"/>
          <p:nvPr/>
        </p:nvSpPr>
        <p:spPr>
          <a:xfrm>
            <a:off x="10128811" y="14269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. S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99840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Breitbild</PresentationFormat>
  <Paragraphs>3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maraun</dc:creator>
  <cp:lastModifiedBy>Lara</cp:lastModifiedBy>
  <cp:revision>78</cp:revision>
  <cp:lastPrinted>2022-07-26T12:12:50Z</cp:lastPrinted>
  <dcterms:created xsi:type="dcterms:W3CDTF">2022-07-19T10:43:27Z</dcterms:created>
  <dcterms:modified xsi:type="dcterms:W3CDTF">2023-04-17T11:39:30Z</dcterms:modified>
</cp:coreProperties>
</file>